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71" d="100"/>
          <a:sy n="71" d="100"/>
        </p:scale>
        <p:origin x="90" y="5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374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708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778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058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100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767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155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564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392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998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241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4EA10F-9A9D-4C6D-991B-88D66F61F67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E12E7-6593-4015-99CA-64BED06DC19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066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hoek 2"/>
          <p:cNvSpPr/>
          <p:nvPr/>
        </p:nvSpPr>
        <p:spPr>
          <a:xfrm>
            <a:off x="2807747" y="4812065"/>
            <a:ext cx="6766560" cy="15132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mRNA expression of HHLA2 in tumor tissue.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of HHLA2 mRNA expression levels of 23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pullary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squares) and pancreas cancer (circles) tissues with their HHLA2 immunohistochemistry scores. Real Time RT-PCR data are corrected with the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omean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ree housekeeping genes: GUS, PMM1, HPRT1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5943" y="1101135"/>
            <a:ext cx="3630168" cy="3203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650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fbeelding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8011" y="296283"/>
            <a:ext cx="4108704" cy="4221480"/>
          </a:xfrm>
          <a:prstGeom prst="rect">
            <a:avLst/>
          </a:prstGeom>
        </p:spPr>
      </p:pic>
      <p:sp>
        <p:nvSpPr>
          <p:cNvPr id="3" name="Rechthoek 2"/>
          <p:cNvSpPr/>
          <p:nvPr/>
        </p:nvSpPr>
        <p:spPr>
          <a:xfrm>
            <a:off x="3112546" y="5004581"/>
            <a:ext cx="6096000" cy="102842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HHLA2 expression on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i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neural invasive tissue.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histochemical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aining for HHLA2 on pancreatic cancer tissue showing HHLA2 expression on neural tissue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102247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3</Words>
  <Application>Microsoft Office PowerPoint</Application>
  <PresentationFormat>Breedbeeld</PresentationFormat>
  <Paragraphs>3</Paragraphs>
  <Slides>2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Kantoorthema</vt:lpstr>
      <vt:lpstr>PowerPoint-presentatie</vt:lpstr>
      <vt:lpstr>PowerPoint-presentatie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J. Kwekkeboom</dc:creator>
  <cp:lastModifiedBy>P.P.C. Boor</cp:lastModifiedBy>
  <cp:revision>3</cp:revision>
  <dcterms:created xsi:type="dcterms:W3CDTF">2019-10-17T15:28:59Z</dcterms:created>
  <dcterms:modified xsi:type="dcterms:W3CDTF">2020-02-06T09:09:26Z</dcterms:modified>
</cp:coreProperties>
</file>